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61" r:id="rId3"/>
    <p:sldId id="256" r:id="rId4"/>
    <p:sldId id="257" r:id="rId5"/>
    <p:sldId id="258" r:id="rId6"/>
    <p:sldId id="259" r:id="rId7"/>
    <p:sldId id="263" r:id="rId8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pl.Prof. Dr. Wolfgang Bernhard" initials="ADWB" lastIdx="5" clrIdx="0">
    <p:extLst>
      <p:ext uri="{19B8F6BF-5375-455C-9EA6-DF929625EA0E}">
        <p15:presenceInfo xmlns:p15="http://schemas.microsoft.com/office/powerpoint/2012/main" userId="S-1-5-21-863953942-1474399219-3225640801-6370" providerId="AD"/>
      </p:ext>
    </p:extLst>
  </p:cmAuthor>
  <p:cmAuthor id="2" name="Dr. Katrin Böckmann" initials="KB" lastIdx="1" clrIdx="1">
    <p:extLst>
      <p:ext uri="{19B8F6BF-5375-455C-9EA6-DF929625EA0E}">
        <p15:presenceInfo xmlns:p15="http://schemas.microsoft.com/office/powerpoint/2012/main" userId="Dr. Katrin Böckman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4" autoAdjust="0"/>
    <p:restoredTop sz="94660"/>
  </p:normalViewPr>
  <p:slideViewPr>
    <p:cSldViewPr snapToGrid="0">
      <p:cViewPr varScale="1">
        <p:scale>
          <a:sx n="70" d="100"/>
          <a:sy n="70" d="100"/>
        </p:scale>
        <p:origin x="105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04-PROJEKTE%20gesamt\2018-HIPP_CHOLINORAL\ERGEBNISSE-b\de-pc%20neue%20messung\003-minuskorrigiert-4-Cholin%20IIb-Erwachsene-Nur%20D3-PEMT_LowFlow.xlsm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04-PROJEKTE%20gesamt\2018-HIPP_CHOLINORAL\ERGEBNISSE-b\de-pc%20neue%20messung\003-minuskorrigiert-4-Cholin%20IIb-Erwachsene-Nur%20D3-PEMT_LowFlow.xlsm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809123607056921"/>
          <c:y val="4.5208515602216393E-2"/>
          <c:w val="0.80756156188726136"/>
          <c:h val="0.81040828229804607"/>
        </c:manualLayout>
      </c:layout>
      <c:scatterChart>
        <c:scatterStyle val="lineMarker"/>
        <c:varyColors val="0"/>
        <c:ser>
          <c:idx val="0"/>
          <c:order val="0"/>
          <c:tx>
            <c:strRef>
              <c:f>'p187_Conc-Ord2-Summary'!$B$6</c:f>
              <c:strCache>
                <c:ptCount val="1"/>
                <c:pt idx="0">
                  <c:v>D9-Choline chloride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187_Conc-Ordered-Summary'!$CK$70:$CK$85</c:f>
                <c:numCache>
                  <c:formatCode>General</c:formatCode>
                  <c:ptCount val="16"/>
                  <c:pt idx="0">
                    <c:v>5.6982953715864065E-2</c:v>
                  </c:pt>
                  <c:pt idx="1">
                    <c:v>9.1122009796705955E-2</c:v>
                  </c:pt>
                  <c:pt idx="2">
                    <c:v>6.0185727518563492E-2</c:v>
                  </c:pt>
                  <c:pt idx="3">
                    <c:v>5.3932204400854125E-2</c:v>
                  </c:pt>
                  <c:pt idx="4">
                    <c:v>4.0366426547095997E-2</c:v>
                  </c:pt>
                  <c:pt idx="5">
                    <c:v>4.0158565920376976E-2</c:v>
                  </c:pt>
                  <c:pt idx="6">
                    <c:v>6.3998676286027151E-2</c:v>
                  </c:pt>
                  <c:pt idx="7">
                    <c:v>0.10899325950555985</c:v>
                  </c:pt>
                  <c:pt idx="8">
                    <c:v>0.23387274087023757</c:v>
                  </c:pt>
                  <c:pt idx="9">
                    <c:v>0.15963682609675456</c:v>
                  </c:pt>
                  <c:pt idx="10">
                    <c:v>0.71894648189998933</c:v>
                  </c:pt>
                  <c:pt idx="11">
                    <c:v>0.50661386559410015</c:v>
                  </c:pt>
                  <c:pt idx="12">
                    <c:v>0.72964578376938549</c:v>
                  </c:pt>
                  <c:pt idx="13">
                    <c:v>1.0556402259331739</c:v>
                  </c:pt>
                  <c:pt idx="14">
                    <c:v>0.62325451211793514</c:v>
                  </c:pt>
                  <c:pt idx="15">
                    <c:v>0.32902556273808425</c:v>
                  </c:pt>
                </c:numCache>
              </c:numRef>
            </c:plus>
            <c:minus>
              <c:numRef>
                <c:f>'p187_Conc-Ordered-Summary'!$CK$134:$CK$149</c:f>
                <c:numCache>
                  <c:formatCode>General</c:formatCode>
                  <c:ptCount val="16"/>
                  <c:pt idx="0">
                    <c:v>2.9805786551150626E-2</c:v>
                  </c:pt>
                  <c:pt idx="1">
                    <c:v>1.4541653764022527E-2</c:v>
                  </c:pt>
                  <c:pt idx="2">
                    <c:v>0</c:v>
                  </c:pt>
                  <c:pt idx="3">
                    <c:v>2.7762091757760066E-2</c:v>
                  </c:pt>
                  <c:pt idx="4">
                    <c:v>1.6228003813417755E-2</c:v>
                  </c:pt>
                  <c:pt idx="5">
                    <c:v>3.7258108010949503E-2</c:v>
                  </c:pt>
                  <c:pt idx="6">
                    <c:v>5.9480336590661542E-2</c:v>
                  </c:pt>
                  <c:pt idx="7">
                    <c:v>0.10219046623682207</c:v>
                  </c:pt>
                  <c:pt idx="8">
                    <c:v>7.6369092720557141E-2</c:v>
                  </c:pt>
                  <c:pt idx="9">
                    <c:v>0.17131036848807452</c:v>
                  </c:pt>
                  <c:pt idx="10">
                    <c:v>0.25153495200184361</c:v>
                  </c:pt>
                  <c:pt idx="11">
                    <c:v>0.50061415738768633</c:v>
                  </c:pt>
                  <c:pt idx="12">
                    <c:v>0.63863080302172359</c:v>
                  </c:pt>
                  <c:pt idx="13">
                    <c:v>0.39171610350141006</c:v>
                  </c:pt>
                  <c:pt idx="14">
                    <c:v>0.49482761039294609</c:v>
                  </c:pt>
                  <c:pt idx="15">
                    <c:v>0.310799885221040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p187_Conc-Ordered-Summary'!$F$6:$F$21</c:f>
              <c:numCache>
                <c:formatCode>0.00</c:formatCode>
                <c:ptCount val="16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5</c:v>
                </c:pt>
                <c:pt idx="8">
                  <c:v>6</c:v>
                </c:pt>
                <c:pt idx="9">
                  <c:v>6</c:v>
                </c:pt>
                <c:pt idx="10">
                  <c:v>24</c:v>
                </c:pt>
                <c:pt idx="11">
                  <c:v>33</c:v>
                </c:pt>
                <c:pt idx="12">
                  <c:v>48</c:v>
                </c:pt>
                <c:pt idx="13">
                  <c:v>72</c:v>
                </c:pt>
                <c:pt idx="14">
                  <c:v>96</c:v>
                </c:pt>
                <c:pt idx="15">
                  <c:v>168</c:v>
                </c:pt>
              </c:numCache>
            </c:numRef>
          </c:xVal>
          <c:yVal>
            <c:numRef>
              <c:f>'p187_Conc-Ordered-Summary'!$CK$6:$CK$21</c:f>
              <c:numCache>
                <c:formatCode>0.00</c:formatCode>
                <c:ptCount val="16"/>
                <c:pt idx="0">
                  <c:v>2.9805786551150626E-2</c:v>
                </c:pt>
                <c:pt idx="1">
                  <c:v>1.4541653764022527E-2</c:v>
                </c:pt>
                <c:pt idx="2">
                  <c:v>0</c:v>
                </c:pt>
                <c:pt idx="3">
                  <c:v>2.7762091757760066E-2</c:v>
                </c:pt>
                <c:pt idx="4">
                  <c:v>1.6228003813417755E-2</c:v>
                </c:pt>
                <c:pt idx="5">
                  <c:v>3.7258108010949503E-2</c:v>
                </c:pt>
                <c:pt idx="6">
                  <c:v>5.9480336590661542E-2</c:v>
                </c:pt>
                <c:pt idx="7">
                  <c:v>0.10219046623682207</c:v>
                </c:pt>
                <c:pt idx="8">
                  <c:v>0.10634723726805238</c:v>
                </c:pt>
                <c:pt idx="9">
                  <c:v>0.39775716337231481</c:v>
                </c:pt>
                <c:pt idx="10">
                  <c:v>1.1198759687281348</c:v>
                </c:pt>
                <c:pt idx="11">
                  <c:v>1.6487995287890174</c:v>
                </c:pt>
                <c:pt idx="12">
                  <c:v>1.6896474075839643</c:v>
                </c:pt>
                <c:pt idx="13">
                  <c:v>1.420124637639379</c:v>
                </c:pt>
                <c:pt idx="14">
                  <c:v>1.410306505259433</c:v>
                </c:pt>
                <c:pt idx="15">
                  <c:v>1.05860695296921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9E5-4973-8F0A-189C04B63C27}"/>
            </c:ext>
          </c:extLst>
        </c:ser>
        <c:ser>
          <c:idx val="1"/>
          <c:order val="1"/>
          <c:tx>
            <c:strRef>
              <c:f>'p187_Conc-Ordered-Summary'!$C$22</c:f>
              <c:strCache>
                <c:ptCount val="1"/>
                <c:pt idx="0">
                  <c:v>D9-GPC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10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187_Conc-Ordered-Summary'!$CK$86:$CK$101</c:f>
                <c:numCache>
                  <c:formatCode>General</c:formatCode>
                  <c:ptCount val="1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3.0471724473566816E-2</c:v>
                  </c:pt>
                  <c:pt idx="8">
                    <c:v>0.10435665885942785</c:v>
                  </c:pt>
                  <c:pt idx="9">
                    <c:v>0.17786767682906457</c:v>
                  </c:pt>
                  <c:pt idx="10">
                    <c:v>0.42585257865483217</c:v>
                  </c:pt>
                  <c:pt idx="11">
                    <c:v>0.92830719501262982</c:v>
                  </c:pt>
                  <c:pt idx="12">
                    <c:v>0.47922411267219456</c:v>
                  </c:pt>
                  <c:pt idx="13">
                    <c:v>0.66402502312113465</c:v>
                  </c:pt>
                  <c:pt idx="14">
                    <c:v>0.25729091067113963</c:v>
                  </c:pt>
                  <c:pt idx="15">
                    <c:v>0.2446289994169949</c:v>
                  </c:pt>
                </c:numCache>
              </c:numRef>
            </c:plus>
            <c:minus>
              <c:numRef>
                <c:f>'p187_Conc-Ordered-Summary'!$CK$150:$CK$165</c:f>
                <c:numCache>
                  <c:formatCode>General</c:formatCode>
                  <c:ptCount val="1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1.9926725864619244E-2</c:v>
                  </c:pt>
                  <c:pt idx="8">
                    <c:v>2.5821248778484157E-2</c:v>
                  </c:pt>
                  <c:pt idx="9">
                    <c:v>0.15322173405242898</c:v>
                  </c:pt>
                  <c:pt idx="10">
                    <c:v>0.38619640006070455</c:v>
                  </c:pt>
                  <c:pt idx="11">
                    <c:v>0.46331498391575143</c:v>
                  </c:pt>
                  <c:pt idx="12">
                    <c:v>0.2064503904742635</c:v>
                  </c:pt>
                  <c:pt idx="13">
                    <c:v>9.7821304957059318E-2</c:v>
                  </c:pt>
                  <c:pt idx="14">
                    <c:v>0.1792419587773435</c:v>
                  </c:pt>
                  <c:pt idx="15">
                    <c:v>1.405171035175600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p187_Conc-Ordered-Summary'!$F$22:$F$37</c:f>
              <c:numCache>
                <c:formatCode>0.00</c:formatCode>
                <c:ptCount val="16"/>
                <c:pt idx="0">
                  <c:v>0.15</c:v>
                </c:pt>
                <c:pt idx="1">
                  <c:v>0.65</c:v>
                </c:pt>
                <c:pt idx="2">
                  <c:v>1.1499999999999999</c:v>
                </c:pt>
                <c:pt idx="3">
                  <c:v>1.65</c:v>
                </c:pt>
                <c:pt idx="4">
                  <c:v>2.15</c:v>
                </c:pt>
                <c:pt idx="5">
                  <c:v>3.15</c:v>
                </c:pt>
                <c:pt idx="6">
                  <c:v>4.1500000000000004</c:v>
                </c:pt>
                <c:pt idx="7">
                  <c:v>5.15</c:v>
                </c:pt>
                <c:pt idx="8">
                  <c:v>6.15</c:v>
                </c:pt>
                <c:pt idx="9">
                  <c:v>9.15</c:v>
                </c:pt>
                <c:pt idx="10">
                  <c:v>24.15</c:v>
                </c:pt>
                <c:pt idx="11">
                  <c:v>33.15</c:v>
                </c:pt>
                <c:pt idx="12">
                  <c:v>48.15</c:v>
                </c:pt>
                <c:pt idx="13">
                  <c:v>72.150000000000006</c:v>
                </c:pt>
                <c:pt idx="14">
                  <c:v>96.15</c:v>
                </c:pt>
                <c:pt idx="15">
                  <c:v>168.15</c:v>
                </c:pt>
              </c:numCache>
            </c:numRef>
          </c:xVal>
          <c:yVal>
            <c:numRef>
              <c:f>'p187_Conc-Ordered-Summary'!$CK$22:$CK$37</c:f>
              <c:numCache>
                <c:formatCode>0.00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.9926725864619244E-2</c:v>
                </c:pt>
                <c:pt idx="8">
                  <c:v>2.5821248778484157E-2</c:v>
                </c:pt>
                <c:pt idx="9">
                  <c:v>0.2654984715187213</c:v>
                </c:pt>
                <c:pt idx="10">
                  <c:v>1.0312884802301627</c:v>
                </c:pt>
                <c:pt idx="11">
                  <c:v>1.221787383890435</c:v>
                </c:pt>
                <c:pt idx="12">
                  <c:v>1.1051849136831438</c:v>
                </c:pt>
                <c:pt idx="13">
                  <c:v>0.9027695854896951</c:v>
                </c:pt>
                <c:pt idx="14">
                  <c:v>1.0510858897895567</c:v>
                </c:pt>
                <c:pt idx="15">
                  <c:v>0.641053084494135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9E5-4973-8F0A-189C04B63C27}"/>
            </c:ext>
          </c:extLst>
        </c:ser>
        <c:ser>
          <c:idx val="2"/>
          <c:order val="2"/>
          <c:tx>
            <c:strRef>
              <c:f>'p187_Conc-Ord2-Summary'!$B$38</c:f>
              <c:strCache>
                <c:ptCount val="1"/>
                <c:pt idx="0">
                  <c:v>D9-Phosphocholine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187_Conc-Ordered-Summary'!$CK$102:$CK$117</c:f>
                <c:numCache>
                  <c:formatCode>General</c:formatCode>
                  <c:ptCount val="16"/>
                  <c:pt idx="0">
                    <c:v>3.4597290575230685E-2</c:v>
                  </c:pt>
                  <c:pt idx="1">
                    <c:v>5.143304229921962E-2</c:v>
                  </c:pt>
                  <c:pt idx="2">
                    <c:v>8.9011152876233998E-2</c:v>
                  </c:pt>
                  <c:pt idx="3">
                    <c:v>0.1003968551570555</c:v>
                  </c:pt>
                  <c:pt idx="4">
                    <c:v>6.4115673166900089E-2</c:v>
                  </c:pt>
                  <c:pt idx="5">
                    <c:v>5.686334652985079E-2</c:v>
                  </c:pt>
                  <c:pt idx="6">
                    <c:v>6.2850450978605352E-2</c:v>
                  </c:pt>
                  <c:pt idx="7">
                    <c:v>0.14267105382716233</c:v>
                  </c:pt>
                  <c:pt idx="8">
                    <c:v>5.0933975970591017E-2</c:v>
                  </c:pt>
                  <c:pt idx="9">
                    <c:v>0.22288448290151186</c:v>
                  </c:pt>
                  <c:pt idx="10">
                    <c:v>0.87448603555028814</c:v>
                  </c:pt>
                  <c:pt idx="11">
                    <c:v>0.91189612016622812</c:v>
                  </c:pt>
                  <c:pt idx="12">
                    <c:v>1.1233978599597902</c:v>
                  </c:pt>
                  <c:pt idx="13">
                    <c:v>0.8393145421965702</c:v>
                  </c:pt>
                  <c:pt idx="14">
                    <c:v>0.60838890447610172</c:v>
                  </c:pt>
                  <c:pt idx="15">
                    <c:v>0.56468677053091243</c:v>
                  </c:pt>
                </c:numCache>
              </c:numRef>
            </c:plus>
            <c:minus>
              <c:numRef>
                <c:f>'p187_Conc-Ordered-Summary'!$CK$166:$CK$181</c:f>
                <c:numCache>
                  <c:formatCode>General</c:formatCode>
                  <c:ptCount val="16"/>
                  <c:pt idx="0">
                    <c:v>0</c:v>
                  </c:pt>
                  <c:pt idx="1">
                    <c:v>1.0037591439517352E-2</c:v>
                  </c:pt>
                  <c:pt idx="2">
                    <c:v>6.9741666426643978E-3</c:v>
                  </c:pt>
                  <c:pt idx="3">
                    <c:v>0</c:v>
                  </c:pt>
                  <c:pt idx="4">
                    <c:v>0</c:v>
                  </c:pt>
                  <c:pt idx="5">
                    <c:v>5.4933645670788844E-3</c:v>
                  </c:pt>
                  <c:pt idx="6">
                    <c:v>5.4927053259097657E-2</c:v>
                  </c:pt>
                  <c:pt idx="7">
                    <c:v>5.7427854164494724E-2</c:v>
                  </c:pt>
                  <c:pt idx="8">
                    <c:v>8.7734352329979115E-2</c:v>
                  </c:pt>
                  <c:pt idx="9">
                    <c:v>0.22352753008873494</c:v>
                  </c:pt>
                  <c:pt idx="10">
                    <c:v>0.36028407774937121</c:v>
                  </c:pt>
                  <c:pt idx="11">
                    <c:v>0.96711824442908867</c:v>
                  </c:pt>
                  <c:pt idx="12">
                    <c:v>0.81367549213392087</c:v>
                  </c:pt>
                  <c:pt idx="13">
                    <c:v>0.90290478442301558</c:v>
                  </c:pt>
                  <c:pt idx="14">
                    <c:v>0.83454089820996513</c:v>
                  </c:pt>
                  <c:pt idx="15">
                    <c:v>0.187176467613518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p187_Conc-Ordered-Summary'!$F$38:$F$53</c:f>
              <c:numCache>
                <c:formatCode>0.00</c:formatCode>
                <c:ptCount val="16"/>
                <c:pt idx="0">
                  <c:v>0.3</c:v>
                </c:pt>
                <c:pt idx="1">
                  <c:v>0.8</c:v>
                </c:pt>
                <c:pt idx="2">
                  <c:v>1.3</c:v>
                </c:pt>
                <c:pt idx="3">
                  <c:v>1.8</c:v>
                </c:pt>
                <c:pt idx="4">
                  <c:v>2.2999999999999998</c:v>
                </c:pt>
                <c:pt idx="5">
                  <c:v>3.3</c:v>
                </c:pt>
                <c:pt idx="6">
                  <c:v>4.3</c:v>
                </c:pt>
                <c:pt idx="7">
                  <c:v>5.3</c:v>
                </c:pt>
                <c:pt idx="8">
                  <c:v>6.3</c:v>
                </c:pt>
                <c:pt idx="9">
                  <c:v>9.3000000000000007</c:v>
                </c:pt>
                <c:pt idx="10">
                  <c:v>24.3</c:v>
                </c:pt>
                <c:pt idx="11">
                  <c:v>33.133333333333333</c:v>
                </c:pt>
                <c:pt idx="12">
                  <c:v>48.3</c:v>
                </c:pt>
                <c:pt idx="13">
                  <c:v>72.3</c:v>
                </c:pt>
                <c:pt idx="14">
                  <c:v>96.3</c:v>
                </c:pt>
                <c:pt idx="15">
                  <c:v>168.3</c:v>
                </c:pt>
              </c:numCache>
            </c:numRef>
          </c:xVal>
          <c:yVal>
            <c:numRef>
              <c:f>'p187_Conc-Ordered-Summary'!$CK$38:$CK$53</c:f>
              <c:numCache>
                <c:formatCode>0.00</c:formatCode>
                <c:ptCount val="16"/>
                <c:pt idx="0">
                  <c:v>0</c:v>
                </c:pt>
                <c:pt idx="1">
                  <c:v>1.0037591439517352E-2</c:v>
                </c:pt>
                <c:pt idx="2">
                  <c:v>6.9741666426643978E-3</c:v>
                </c:pt>
                <c:pt idx="3">
                  <c:v>0</c:v>
                </c:pt>
                <c:pt idx="4">
                  <c:v>0</c:v>
                </c:pt>
                <c:pt idx="5">
                  <c:v>1.9762530302378373E-3</c:v>
                </c:pt>
                <c:pt idx="6">
                  <c:v>4.368279573512926E-2</c:v>
                </c:pt>
                <c:pt idx="7">
                  <c:v>0.14598864195207317</c:v>
                </c:pt>
                <c:pt idx="8">
                  <c:v>0.27278796878166778</c:v>
                </c:pt>
                <c:pt idx="9">
                  <c:v>0.52404310106531105</c:v>
                </c:pt>
                <c:pt idx="10">
                  <c:v>1.2895428678336094</c:v>
                </c:pt>
                <c:pt idx="11">
                  <c:v>1.8473250268198806</c:v>
                </c:pt>
                <c:pt idx="12">
                  <c:v>1.7320839963201564</c:v>
                </c:pt>
                <c:pt idx="13">
                  <c:v>1.8157184532013559</c:v>
                </c:pt>
                <c:pt idx="14">
                  <c:v>1.6624505312499354</c:v>
                </c:pt>
                <c:pt idx="15">
                  <c:v>1.12002609349501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9E5-4973-8F0A-189C04B63C27}"/>
            </c:ext>
          </c:extLst>
        </c:ser>
        <c:ser>
          <c:idx val="3"/>
          <c:order val="3"/>
          <c:tx>
            <c:strRef>
              <c:f>'p187_Conc-Ordered-Summary'!$C$54</c:f>
              <c:strCache>
                <c:ptCount val="1"/>
                <c:pt idx="0">
                  <c:v>D9-POPC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187_Conc-Ordered-Summary'!$CK$118:$CK$133</c:f>
                <c:numCache>
                  <c:formatCode>General</c:formatCode>
                  <c:ptCount val="16"/>
                  <c:pt idx="0">
                    <c:v>0.13117124771052746</c:v>
                  </c:pt>
                  <c:pt idx="1">
                    <c:v>0.15352244449137989</c:v>
                  </c:pt>
                  <c:pt idx="2">
                    <c:v>0.19532835124092865</c:v>
                  </c:pt>
                  <c:pt idx="3">
                    <c:v>0.14061845409037674</c:v>
                  </c:pt>
                  <c:pt idx="4">
                    <c:v>0.13508753677820495</c:v>
                  </c:pt>
                  <c:pt idx="5">
                    <c:v>0.19385410362856997</c:v>
                  </c:pt>
                  <c:pt idx="6">
                    <c:v>0.14753175207989039</c:v>
                  </c:pt>
                  <c:pt idx="7">
                    <c:v>4.7195547893305739E-2</c:v>
                  </c:pt>
                  <c:pt idx="8">
                    <c:v>0.13412293715330378</c:v>
                  </c:pt>
                  <c:pt idx="9">
                    <c:v>3.2167529108512283E-2</c:v>
                  </c:pt>
                  <c:pt idx="10">
                    <c:v>0.35765179668199465</c:v>
                  </c:pt>
                  <c:pt idx="11">
                    <c:v>0.80651381628476537</c:v>
                  </c:pt>
                  <c:pt idx="12">
                    <c:v>0.56669311917904652</c:v>
                  </c:pt>
                  <c:pt idx="13">
                    <c:v>0.97103376480459636</c:v>
                  </c:pt>
                  <c:pt idx="14">
                    <c:v>0.41548004839888941</c:v>
                  </c:pt>
                  <c:pt idx="15">
                    <c:v>1.9713009366246093E-2</c:v>
                  </c:pt>
                </c:numCache>
              </c:numRef>
            </c:plus>
            <c:minus>
              <c:numRef>
                <c:f>'p187_Conc-Ordered-Summary'!$CK$182:$CK$197</c:f>
                <c:numCache>
                  <c:formatCode>General</c:formatCode>
                  <c:ptCount val="16"/>
                  <c:pt idx="0">
                    <c:v>5.2636510457296948E-2</c:v>
                  </c:pt>
                  <c:pt idx="1">
                    <c:v>7.604251971162268E-2</c:v>
                  </c:pt>
                  <c:pt idx="2">
                    <c:v>1.849736981011732E-2</c:v>
                  </c:pt>
                  <c:pt idx="3">
                    <c:v>6.0650294347459693E-2</c:v>
                  </c:pt>
                  <c:pt idx="4">
                    <c:v>2.4818797692755259E-2</c:v>
                  </c:pt>
                  <c:pt idx="5">
                    <c:v>6.4129756719673137E-2</c:v>
                  </c:pt>
                  <c:pt idx="6">
                    <c:v>8.479548895583422E-2</c:v>
                  </c:pt>
                  <c:pt idx="7">
                    <c:v>0.10743591814895345</c:v>
                  </c:pt>
                  <c:pt idx="8">
                    <c:v>0.11334035703287462</c:v>
                  </c:pt>
                  <c:pt idx="9">
                    <c:v>0.18661334356816289</c:v>
                  </c:pt>
                  <c:pt idx="10">
                    <c:v>0.27437341613362343</c:v>
                  </c:pt>
                  <c:pt idx="11">
                    <c:v>9.0922400331771902E-2</c:v>
                  </c:pt>
                  <c:pt idx="12">
                    <c:v>0.58722412680645242</c:v>
                  </c:pt>
                  <c:pt idx="13">
                    <c:v>0.20501512185835624</c:v>
                  </c:pt>
                  <c:pt idx="14">
                    <c:v>0.42458216365251467</c:v>
                  </c:pt>
                  <c:pt idx="15">
                    <c:v>0.163026644954405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p187_Conc-Ordered-Summary'!$F$54:$F$69</c:f>
              <c:numCache>
                <c:formatCode>0.00</c:formatCode>
                <c:ptCount val="16"/>
                <c:pt idx="0">
                  <c:v>0.45</c:v>
                </c:pt>
                <c:pt idx="1">
                  <c:v>0.95</c:v>
                </c:pt>
                <c:pt idx="2">
                  <c:v>1.45</c:v>
                </c:pt>
                <c:pt idx="3">
                  <c:v>1.95</c:v>
                </c:pt>
                <c:pt idx="4">
                  <c:v>2.4500000000000002</c:v>
                </c:pt>
                <c:pt idx="5">
                  <c:v>3.45</c:v>
                </c:pt>
                <c:pt idx="6">
                  <c:v>4.45</c:v>
                </c:pt>
                <c:pt idx="7">
                  <c:v>5.45</c:v>
                </c:pt>
                <c:pt idx="8">
                  <c:v>6.45</c:v>
                </c:pt>
                <c:pt idx="9">
                  <c:v>9.4499999999999993</c:v>
                </c:pt>
                <c:pt idx="10">
                  <c:v>24.45</c:v>
                </c:pt>
                <c:pt idx="11">
                  <c:v>33.450000000000003</c:v>
                </c:pt>
                <c:pt idx="12">
                  <c:v>48.45</c:v>
                </c:pt>
                <c:pt idx="13">
                  <c:v>72.45</c:v>
                </c:pt>
                <c:pt idx="14">
                  <c:v>96.45</c:v>
                </c:pt>
                <c:pt idx="15">
                  <c:v>168.45</c:v>
                </c:pt>
              </c:numCache>
            </c:numRef>
          </c:xVal>
          <c:yVal>
            <c:numRef>
              <c:f>'p187_Conc-Ordered-Summary'!$CK$54:$CK$69</c:f>
              <c:numCache>
                <c:formatCode>0.00</c:formatCode>
                <c:ptCount val="16"/>
                <c:pt idx="0">
                  <c:v>5.2636510457296948E-2</c:v>
                </c:pt>
                <c:pt idx="1">
                  <c:v>7.604251971162268E-2</c:v>
                </c:pt>
                <c:pt idx="2">
                  <c:v>1.849736981011732E-2</c:v>
                </c:pt>
                <c:pt idx="3">
                  <c:v>6.0650294347459693E-2</c:v>
                </c:pt>
                <c:pt idx="4">
                  <c:v>4.5661306265945056E-2</c:v>
                </c:pt>
                <c:pt idx="5">
                  <c:v>6.4129756719673137E-2</c:v>
                </c:pt>
                <c:pt idx="6">
                  <c:v>0.10543125686057403</c:v>
                </c:pt>
                <c:pt idx="7">
                  <c:v>0.14034723025517096</c:v>
                </c:pt>
                <c:pt idx="8">
                  <c:v>0.14249776142791529</c:v>
                </c:pt>
                <c:pt idx="9">
                  <c:v>0.3309469038370485</c:v>
                </c:pt>
                <c:pt idx="10">
                  <c:v>0.95046716806859977</c:v>
                </c:pt>
                <c:pt idx="11">
                  <c:v>1.2662035998200758</c:v>
                </c:pt>
                <c:pt idx="12">
                  <c:v>1.6494838740207878</c:v>
                </c:pt>
                <c:pt idx="13">
                  <c:v>1.4680275437900097</c:v>
                </c:pt>
                <c:pt idx="14">
                  <c:v>1.6849246918171907</c:v>
                </c:pt>
                <c:pt idx="15">
                  <c:v>1.52796101900232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9E5-4973-8F0A-189C04B63C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09868328"/>
        <c:axId val="621673936"/>
      </c:scatterChart>
      <c:valAx>
        <c:axId val="409868328"/>
        <c:scaling>
          <c:orientation val="minMax"/>
          <c:max val="17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de-DE"/>
                  <a:t>Time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de-DE"/>
            </a:p>
          </c:txPr>
        </c:title>
        <c:numFmt formatCode="0" sourceLinked="0"/>
        <c:majorTickMark val="out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de-DE"/>
          </a:p>
        </c:txPr>
        <c:crossAx val="621673936"/>
        <c:crosses val="autoZero"/>
        <c:crossBetween val="midCat"/>
        <c:majorUnit val="24"/>
        <c:minorUnit val="12"/>
      </c:valAx>
      <c:valAx>
        <c:axId val="621673936"/>
        <c:scaling>
          <c:orientation val="minMax"/>
          <c:max val="3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de-DE"/>
                  <a:t>Concentration (µmol/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de-DE"/>
            </a:p>
          </c:txPr>
        </c:title>
        <c:numFmt formatCode="0" sourceLinked="0"/>
        <c:majorTickMark val="out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de-DE"/>
          </a:p>
        </c:txPr>
        <c:crossAx val="409868328"/>
        <c:crosses val="autoZero"/>
        <c:crossBetween val="midCat"/>
        <c:majorUnit val="1"/>
        <c:minorUnit val="0.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6157316939131142"/>
          <c:y val="0.66204626473929573"/>
          <c:w val="0.63212351186477111"/>
          <c:h val="0.1876434755357073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Arial Narrow" panose="020B0606020202030204" pitchFamily="34" charset="0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Arial Narrow" panose="020B0606020202030204" pitchFamily="34" charset="0"/>
        </a:defRPr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779096509956914"/>
          <c:y val="2.3229811846838217E-2"/>
          <c:w val="0.82853246279423409"/>
          <c:h val="0.84609526318029926"/>
        </c:manualLayout>
      </c:layout>
      <c:scatterChart>
        <c:scatterStyle val="lineMarker"/>
        <c:varyColors val="0"/>
        <c:ser>
          <c:idx val="2"/>
          <c:order val="0"/>
          <c:tx>
            <c:v>6h</c:v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7"/>
            <c:spPr>
              <a:solidFill>
                <a:schemeClr val="bg1">
                  <a:lumMod val="5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-1.3256244405931355E-2"/>
                  <c:y val="-4.8580536219528618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marL="0" indent="0">
                    <a:buFont typeface="Symbol" panose="05050102010706020507" pitchFamily="18" charset="2"/>
                    <a:buNone/>
                    <a:defRPr sz="14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 Narrow" panose="020B0606020202030204" pitchFamily="34" charset="0"/>
                      <a:ea typeface="+mn-ea"/>
                      <a:cs typeface="+mn-cs"/>
                    </a:defRPr>
                  </a:pPr>
                  <a:endParaRPr lang="de-DE"/>
                </a:p>
              </c:txPr>
            </c:trendlineLbl>
          </c:trendline>
          <c:xVal>
            <c:numRef>
              <c:f>'Statistik und korrelationen'!$CP$198:$CP$221</c:f>
              <c:numCache>
                <c:formatCode>#,##0.00</c:formatCode>
                <c:ptCount val="24"/>
                <c:pt idx="0">
                  <c:v>8.2095101555709024E-2</c:v>
                </c:pt>
                <c:pt idx="1">
                  <c:v>5.2895483068043446E-2</c:v>
                </c:pt>
                <c:pt idx="2">
                  <c:v>5.2388739531055863E-2</c:v>
                </c:pt>
                <c:pt idx="3">
                  <c:v>5.7340724147589076E-2</c:v>
                </c:pt>
                <c:pt idx="4">
                  <c:v>5.5709370547749708E-2</c:v>
                </c:pt>
                <c:pt idx="5">
                  <c:v>6.2277175891365597E-2</c:v>
                </c:pt>
                <c:pt idx="6">
                  <c:v>0.1183001619173172</c:v>
                </c:pt>
                <c:pt idx="7">
                  <c:v>7.7130825206787337E-2</c:v>
                </c:pt>
                <c:pt idx="8">
                  <c:v>4.9394301160323506E-2</c:v>
                </c:pt>
                <c:pt idx="9">
                  <c:v>3.1891097554359184E-2</c:v>
                </c:pt>
                <c:pt idx="10">
                  <c:v>5.0829009287363322E-2</c:v>
                </c:pt>
                <c:pt idx="11">
                  <c:v>5.2790544807196631E-2</c:v>
                </c:pt>
                <c:pt idx="12">
                  <c:v>6.0771914398201524E-2</c:v>
                </c:pt>
                <c:pt idx="13">
                  <c:v>5.5770276019236231E-2</c:v>
                </c:pt>
                <c:pt idx="14">
                  <c:v>5.0572886689594636E-2</c:v>
                </c:pt>
                <c:pt idx="15">
                  <c:v>3.8166690621165879E-2</c:v>
                </c:pt>
                <c:pt idx="16">
                  <c:v>4.9630721270898591E-2</c:v>
                </c:pt>
                <c:pt idx="17">
                  <c:v>5.2500022186466218E-2</c:v>
                </c:pt>
                <c:pt idx="18">
                  <c:v>4.6379893484194745E-2</c:v>
                </c:pt>
                <c:pt idx="19">
                  <c:v>2.3543471983005066E-2</c:v>
                </c:pt>
                <c:pt idx="20">
                  <c:v>3.0693827059525669E-2</c:v>
                </c:pt>
                <c:pt idx="21">
                  <c:v>2.8172843598338267E-2</c:v>
                </c:pt>
                <c:pt idx="22">
                  <c:v>3.6330352396616625E-2</c:v>
                </c:pt>
                <c:pt idx="23">
                  <c:v>4.4960168171764091E-2</c:v>
                </c:pt>
              </c:numCache>
            </c:numRef>
          </c:xVal>
          <c:yVal>
            <c:numRef>
              <c:f>'Statistik und korrelationen'!$BY$198:$BY$221</c:f>
              <c:numCache>
                <c:formatCode>#,##0.00</c:formatCode>
                <c:ptCount val="24"/>
                <c:pt idx="0">
                  <c:v>1.1473020746755036</c:v>
                </c:pt>
                <c:pt idx="1">
                  <c:v>0.61212943742076886</c:v>
                </c:pt>
                <c:pt idx="2">
                  <c:v>0.25379408188747921</c:v>
                </c:pt>
                <c:pt idx="3">
                  <c:v>0.25455977268005364</c:v>
                </c:pt>
                <c:pt idx="4">
                  <c:v>0.39819196707378457</c:v>
                </c:pt>
                <c:pt idx="5">
                  <c:v>0.12434330978335299</c:v>
                </c:pt>
                <c:pt idx="6">
                  <c:v>0.47273857534107661</c:v>
                </c:pt>
                <c:pt idx="7">
                  <c:v>0.27716742458800525</c:v>
                </c:pt>
                <c:pt idx="8">
                  <c:v>0.3797622958479932</c:v>
                </c:pt>
                <c:pt idx="9">
                  <c:v>0.17669943610580177</c:v>
                </c:pt>
                <c:pt idx="10">
                  <c:v>0.19019778572283322</c:v>
                </c:pt>
                <c:pt idx="11">
                  <c:v>0.21553537879159665</c:v>
                </c:pt>
                <c:pt idx="12">
                  <c:v>1.1799272575993407</c:v>
                </c:pt>
                <c:pt idx="13">
                  <c:v>0.55089147086097345</c:v>
                </c:pt>
                <c:pt idx="14">
                  <c:v>0.51636368828292456</c:v>
                </c:pt>
                <c:pt idx="15">
                  <c:v>0.24693292705235165</c:v>
                </c:pt>
                <c:pt idx="16">
                  <c:v>0.38472633847159354</c:v>
                </c:pt>
                <c:pt idx="17">
                  <c:v>0.46966828711610276</c:v>
                </c:pt>
                <c:pt idx="18">
                  <c:v>0.95058266999854468</c:v>
                </c:pt>
                <c:pt idx="19">
                  <c:v>0.33375011743167793</c:v>
                </c:pt>
                <c:pt idx="20">
                  <c:v>0.38551950334097557</c:v>
                </c:pt>
                <c:pt idx="21">
                  <c:v>0.1486088107392752</c:v>
                </c:pt>
                <c:pt idx="22">
                  <c:v>0.53645543836839171</c:v>
                </c:pt>
                <c:pt idx="23">
                  <c:v>0.12540312705698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2BB-462A-9353-F4F77B25E69C}"/>
            </c:ext>
          </c:extLst>
        </c:ser>
        <c:ser>
          <c:idx val="0"/>
          <c:order val="1"/>
          <c:tx>
            <c:v>9h</c:v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5.5426898806274147E-2"/>
                  <c:y val="-0.12117385326834146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marL="0" indent="0">
                    <a:buFont typeface="Symbol" panose="05050102010706020507" pitchFamily="18" charset="2"/>
                    <a:buNone/>
                    <a:defRPr sz="16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 Narrow" panose="020B0606020202030204" pitchFamily="34" charset="0"/>
                      <a:ea typeface="+mn-ea"/>
                      <a:cs typeface="+mn-cs"/>
                    </a:defRPr>
                  </a:pPr>
                  <a:endParaRPr lang="de-DE"/>
                </a:p>
              </c:txPr>
            </c:trendlineLbl>
          </c:trendline>
          <c:xVal>
            <c:numRef>
              <c:f>'Statistik und korrelationen'!$CP$222:$CP$245</c:f>
              <c:numCache>
                <c:formatCode>#,##0.00</c:formatCode>
                <c:ptCount val="24"/>
                <c:pt idx="0">
                  <c:v>7.1445682819296363E-2</c:v>
                </c:pt>
                <c:pt idx="1">
                  <c:v>3.9663769160977497E-2</c:v>
                </c:pt>
                <c:pt idx="2">
                  <c:v>3.1997897998308447E-2</c:v>
                </c:pt>
                <c:pt idx="3">
                  <c:v>3.2212864369136729E-2</c:v>
                </c:pt>
                <c:pt idx="4">
                  <c:v>3.1629852986064848E-2</c:v>
                </c:pt>
                <c:pt idx="5">
                  <c:v>2.9559253971024217E-2</c:v>
                </c:pt>
                <c:pt idx="6">
                  <c:v>6.8182742951804973E-2</c:v>
                </c:pt>
                <c:pt idx="7">
                  <c:v>4.7624032636858896E-2</c:v>
                </c:pt>
                <c:pt idx="8">
                  <c:v>3.0819055390323768E-2</c:v>
                </c:pt>
                <c:pt idx="9">
                  <c:v>2.312394296360237E-2</c:v>
                </c:pt>
                <c:pt idx="10">
                  <c:v>3.2355102464567666E-2</c:v>
                </c:pt>
                <c:pt idx="11">
                  <c:v>3.2196875236361722E-2</c:v>
                </c:pt>
                <c:pt idx="12">
                  <c:v>4.9690806973829126E-2</c:v>
                </c:pt>
                <c:pt idx="13">
                  <c:v>4.1296679255970345E-2</c:v>
                </c:pt>
                <c:pt idx="14">
                  <c:v>3.2769616395711285E-2</c:v>
                </c:pt>
                <c:pt idx="15">
                  <c:v>3.3575037583945921E-2</c:v>
                </c:pt>
                <c:pt idx="16">
                  <c:v>3.2835088434885161E-2</c:v>
                </c:pt>
                <c:pt idx="17">
                  <c:v>4.0877658420338407E-2</c:v>
                </c:pt>
                <c:pt idx="18">
                  <c:v>2.8157984127311231E-2</c:v>
                </c:pt>
                <c:pt idx="19">
                  <c:v>2.4006839894616234E-2</c:v>
                </c:pt>
                <c:pt idx="20">
                  <c:v>1.7511057998830595E-2</c:v>
                </c:pt>
                <c:pt idx="21">
                  <c:v>2.3300779457459769E-2</c:v>
                </c:pt>
                <c:pt idx="22">
                  <c:v>2.2187369854446311E-2</c:v>
                </c:pt>
                <c:pt idx="23">
                  <c:v>3.2750205641547528E-2</c:v>
                </c:pt>
              </c:numCache>
            </c:numRef>
          </c:xVal>
          <c:yVal>
            <c:numRef>
              <c:f>'Statistik und korrelationen'!$BY$222:$BY$245</c:f>
              <c:numCache>
                <c:formatCode>#,##0.00</c:formatCode>
                <c:ptCount val="24"/>
                <c:pt idx="0">
                  <c:v>1.7525559411873994</c:v>
                </c:pt>
                <c:pt idx="1">
                  <c:v>0.76096141424536179</c:v>
                </c:pt>
                <c:pt idx="2">
                  <c:v>0.4885002326404973</c:v>
                </c:pt>
                <c:pt idx="3">
                  <c:v>0.43709963359856574</c:v>
                </c:pt>
                <c:pt idx="4">
                  <c:v>0.78847144269227709</c:v>
                </c:pt>
                <c:pt idx="5">
                  <c:v>0.31579885352716569</c:v>
                </c:pt>
                <c:pt idx="6">
                  <c:v>0.92874123836179201</c:v>
                </c:pt>
                <c:pt idx="7">
                  <c:v>0.56101387871303532</c:v>
                </c:pt>
                <c:pt idx="8">
                  <c:v>0.70118206440656183</c:v>
                </c:pt>
                <c:pt idx="9">
                  <c:v>0.30819471840434393</c:v>
                </c:pt>
                <c:pt idx="10">
                  <c:v>0.30693197278094392</c:v>
                </c:pt>
                <c:pt idx="11">
                  <c:v>0.42102863777794569</c:v>
                </c:pt>
                <c:pt idx="12">
                  <c:v>1.8557130206401318</c:v>
                </c:pt>
                <c:pt idx="13">
                  <c:v>0.77463602810559684</c:v>
                </c:pt>
                <c:pt idx="14">
                  <c:v>0.71344625625686431</c:v>
                </c:pt>
                <c:pt idx="15">
                  <c:v>0.31649428022161796</c:v>
                </c:pt>
                <c:pt idx="16">
                  <c:v>0.45770729027555002</c:v>
                </c:pt>
                <c:pt idx="17">
                  <c:v>1.0287019892797085</c:v>
                </c:pt>
                <c:pt idx="18">
                  <c:v>1.2935174891177943</c:v>
                </c:pt>
                <c:pt idx="19">
                  <c:v>0.58089454565979337</c:v>
                </c:pt>
                <c:pt idx="20">
                  <c:v>0.5172812429147956</c:v>
                </c:pt>
                <c:pt idx="21">
                  <c:v>0.31618599982526036</c:v>
                </c:pt>
                <c:pt idx="22">
                  <c:v>0.58703879196560604</c:v>
                </c:pt>
                <c:pt idx="23">
                  <c:v>0.109317463451704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2BB-462A-9353-F4F77B25E69C}"/>
            </c:ext>
          </c:extLst>
        </c:ser>
        <c:ser>
          <c:idx val="1"/>
          <c:order val="2"/>
          <c:tx>
            <c:v>24h</c:v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-2.8560614547715295E-2"/>
                  <c:y val="-0.11488230637836937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marL="0" indent="0">
                    <a:buFont typeface="Symbol" panose="05050102010706020507" pitchFamily="18" charset="2"/>
                    <a:buNone/>
                    <a:defRPr sz="16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 Narrow" panose="020B0606020202030204" pitchFamily="34" charset="0"/>
                      <a:ea typeface="+mn-ea"/>
                      <a:cs typeface="+mn-cs"/>
                    </a:defRPr>
                  </a:pPr>
                  <a:endParaRPr lang="de-DE"/>
                </a:p>
              </c:txPr>
            </c:trendlineLbl>
          </c:trendline>
          <c:xVal>
            <c:numRef>
              <c:f>'Statistik und korrelationen'!$CP$246:$CP$269</c:f>
              <c:numCache>
                <c:formatCode>#,##0.00</c:formatCode>
                <c:ptCount val="24"/>
                <c:pt idx="0">
                  <c:v>3.7571582278949391E-2</c:v>
                </c:pt>
                <c:pt idx="1">
                  <c:v>2.1639706520172407E-2</c:v>
                </c:pt>
                <c:pt idx="2">
                  <c:v>2.200909013877151E-2</c:v>
                </c:pt>
                <c:pt idx="3">
                  <c:v>2.2915989322065816E-2</c:v>
                </c:pt>
                <c:pt idx="4">
                  <c:v>1.7736494516697808E-2</c:v>
                </c:pt>
                <c:pt idx="5">
                  <c:v>1.8530790629215872E-2</c:v>
                </c:pt>
                <c:pt idx="6">
                  <c:v>3.6282945617024547E-2</c:v>
                </c:pt>
                <c:pt idx="7">
                  <c:v>2.6628266031705275E-2</c:v>
                </c:pt>
                <c:pt idx="8">
                  <c:v>1.564827366637906E-2</c:v>
                </c:pt>
                <c:pt idx="9">
                  <c:v>1.5896675351189785E-2</c:v>
                </c:pt>
                <c:pt idx="10">
                  <c:v>2.418342868588768E-2</c:v>
                </c:pt>
                <c:pt idx="11">
                  <c:v>1.6802179395671749E-2</c:v>
                </c:pt>
                <c:pt idx="12">
                  <c:v>2.7150558523897406E-2</c:v>
                </c:pt>
                <c:pt idx="13">
                  <c:v>2.1354979757122517E-2</c:v>
                </c:pt>
                <c:pt idx="14">
                  <c:v>1.9042743532214589E-2</c:v>
                </c:pt>
                <c:pt idx="15">
                  <c:v>1.9004133498762867E-2</c:v>
                </c:pt>
                <c:pt idx="16">
                  <c:v>1.7685395915048353E-2</c:v>
                </c:pt>
                <c:pt idx="17">
                  <c:v>1.9989945808888979E-2</c:v>
                </c:pt>
                <c:pt idx="18">
                  <c:v>1.8087519002693571E-2</c:v>
                </c:pt>
                <c:pt idx="19">
                  <c:v>1.1871769835766099E-2</c:v>
                </c:pt>
                <c:pt idx="20">
                  <c:v>1.188131333632448E-2</c:v>
                </c:pt>
                <c:pt idx="21">
                  <c:v>1.6065976586242297E-2</c:v>
                </c:pt>
                <c:pt idx="22">
                  <c:v>1.7307089856508168E-2</c:v>
                </c:pt>
                <c:pt idx="23">
                  <c:v>2.0002921802966193E-2</c:v>
                </c:pt>
              </c:numCache>
            </c:numRef>
          </c:xVal>
          <c:yVal>
            <c:numRef>
              <c:f>'Statistik und korrelationen'!$BY$246:$BY$269</c:f>
              <c:numCache>
                <c:formatCode>#,##0.00</c:formatCode>
                <c:ptCount val="24"/>
                <c:pt idx="0">
                  <c:v>3.7992638386047051</c:v>
                </c:pt>
                <c:pt idx="1">
                  <c:v>2.2626782019659135</c:v>
                </c:pt>
                <c:pt idx="2">
                  <c:v>1.0406378331148429</c:v>
                </c:pt>
                <c:pt idx="3">
                  <c:v>1.4383761838379885</c:v>
                </c:pt>
                <c:pt idx="4">
                  <c:v>1.2385017241225256</c:v>
                </c:pt>
                <c:pt idx="5">
                  <c:v>0.56342997781823634</c:v>
                </c:pt>
                <c:pt idx="6">
                  <c:v>3.0473863067036384</c:v>
                </c:pt>
                <c:pt idx="7">
                  <c:v>1.3736736734965769</c:v>
                </c:pt>
                <c:pt idx="8">
                  <c:v>1.1358749333898732</c:v>
                </c:pt>
                <c:pt idx="9">
                  <c:v>1.7775770637499018</c:v>
                </c:pt>
                <c:pt idx="10">
                  <c:v>0.49457207275377346</c:v>
                </c:pt>
                <c:pt idx="11">
                  <c:v>0.77873569836499623</c:v>
                </c:pt>
                <c:pt idx="12">
                  <c:v>5.1364463918405345</c:v>
                </c:pt>
                <c:pt idx="13">
                  <c:v>2.566970427277977</c:v>
                </c:pt>
                <c:pt idx="14">
                  <c:v>1.1935201396421504</c:v>
                </c:pt>
                <c:pt idx="15">
                  <c:v>1.144147624919678</c:v>
                </c:pt>
                <c:pt idx="16">
                  <c:v>0.77034202304384214</c:v>
                </c:pt>
                <c:pt idx="17">
                  <c:v>1.8274505278858042</c:v>
                </c:pt>
                <c:pt idx="18">
                  <c:v>2.8470529707312009</c:v>
                </c:pt>
                <c:pt idx="19">
                  <c:v>1.5926172575117825</c:v>
                </c:pt>
                <c:pt idx="20">
                  <c:v>1.3259840483156424</c:v>
                </c:pt>
                <c:pt idx="21">
                  <c:v>0.80469628133822713</c:v>
                </c:pt>
                <c:pt idx="22">
                  <c:v>0.86060324742333894</c:v>
                </c:pt>
                <c:pt idx="23">
                  <c:v>1.00937982350403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D2BB-462A-9353-F4F77B25E6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7510375"/>
        <c:axId val="527513327"/>
      </c:scatterChart>
      <c:valAx>
        <c:axId val="527510375"/>
        <c:scaling>
          <c:orientation val="minMax"/>
          <c:max val="0.12000000000000001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dirty="0"/>
                  <a:t>Enrichment (D9-Betaine / Total Betaine)</a:t>
                </a:r>
              </a:p>
            </c:rich>
          </c:tx>
          <c:layout>
            <c:manualLayout>
              <c:xMode val="edge"/>
              <c:yMode val="edge"/>
              <c:x val="0.21520092594884799"/>
              <c:y val="0.944910046087554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de-DE"/>
            </a:p>
          </c:txPr>
        </c:title>
        <c:numFmt formatCode="#,##0.00" sourceLinked="1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de-DE"/>
          </a:p>
        </c:txPr>
        <c:crossAx val="527513327"/>
        <c:crosses val="autoZero"/>
        <c:crossBetween val="midCat"/>
        <c:minorUnit val="1.0000000000000002E-2"/>
      </c:valAx>
      <c:valAx>
        <c:axId val="527513327"/>
        <c:scaling>
          <c:orientation val="minMax"/>
          <c:max val="6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/>
                  <a:t>D3-PC Concentration  (µmol/L)</a:t>
                </a:r>
              </a:p>
            </c:rich>
          </c:tx>
          <c:layout>
            <c:manualLayout>
              <c:xMode val="edge"/>
              <c:yMode val="edge"/>
              <c:x val="1.0579641801712951E-4"/>
              <c:y val="0.2604231517250920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de-DE"/>
            </a:p>
          </c:txPr>
        </c:title>
        <c:numFmt formatCode="#,##0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de-DE"/>
          </a:p>
        </c:txPr>
        <c:crossAx val="527510375"/>
        <c:crosses val="autoZero"/>
        <c:crossBetween val="midCat"/>
        <c:majorUnit val="1"/>
        <c:minorUnit val="0.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6808491814548876"/>
          <c:y val="3.7494457163599337E-2"/>
          <c:w val="0.28023730685894499"/>
          <c:h val="0.1484773272346390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 Narrow" panose="020B0606020202030204" pitchFamily="34" charset="0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latin typeface="Arial Narrow" panose="020B0606020202030204" pitchFamily="34" charset="0"/>
        </a:defRPr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825F-A72F-4792-BE25-919D88E90386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289B5-CF51-4E95-8486-7AD3FDAA4F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4738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825F-A72F-4792-BE25-919D88E90386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289B5-CF51-4E95-8486-7AD3FDAA4F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3467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825F-A72F-4792-BE25-919D88E90386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289B5-CF51-4E95-8486-7AD3FDAA4F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76089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825F-A72F-4792-BE25-919D88E90386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289B5-CF51-4E95-8486-7AD3FDAA4F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21818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825F-A72F-4792-BE25-919D88E90386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289B5-CF51-4E95-8486-7AD3FDAA4F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0155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825F-A72F-4792-BE25-919D88E90386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289B5-CF51-4E95-8486-7AD3FDAA4F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5261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825F-A72F-4792-BE25-919D88E90386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289B5-CF51-4E95-8486-7AD3FDAA4F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2366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825F-A72F-4792-BE25-919D88E90386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289B5-CF51-4E95-8486-7AD3FDAA4F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7984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825F-A72F-4792-BE25-919D88E90386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289B5-CF51-4E95-8486-7AD3FDAA4F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9715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825F-A72F-4792-BE25-919D88E90386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289B5-CF51-4E95-8486-7AD3FDAA4F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4625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825F-A72F-4792-BE25-919D88E90386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289B5-CF51-4E95-8486-7AD3FDAA4F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6289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94825F-A72F-4792-BE25-919D88E90386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9289B5-CF51-4E95-8486-7AD3FDAA4F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2354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>
            <a:extLst>
              <a:ext uri="{FF2B5EF4-FFF2-40B4-BE49-F238E27FC236}">
                <a16:creationId xmlns:a16="http://schemas.microsoft.com/office/drawing/2014/main" id="{2EDA3EC5-F811-4B59-94AF-8A96723845DE}"/>
              </a:ext>
            </a:extLst>
          </p:cNvPr>
          <p:cNvSpPr/>
          <p:nvPr/>
        </p:nvSpPr>
        <p:spPr>
          <a:xfrm>
            <a:off x="676656" y="640080"/>
            <a:ext cx="10552176" cy="22879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10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Different choline supplement metabolism in adults using Deuterium labelling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Katrin A. Böckmann</a:t>
            </a:r>
            <a:r>
              <a:rPr lang="en-US" sz="1200" baseline="300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, Axel R. Franz</a:t>
            </a:r>
            <a:r>
              <a:rPr lang="en-US" sz="1200" baseline="300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,2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, Anna Shunova</a:t>
            </a:r>
            <a:r>
              <a:rPr lang="en-US" sz="1200" baseline="300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,</a:t>
            </a:r>
            <a:r>
              <a:rPr lang="en-US" sz="1200" baseline="300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Michaela Minarski</a:t>
            </a:r>
            <a:r>
              <a:rPr lang="en-US" sz="1200" baseline="300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, Cornelia Wiechers</a:t>
            </a:r>
            <a:r>
              <a:rPr lang="en-US" sz="1200" baseline="300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, Christian F. Poets</a:t>
            </a:r>
            <a:r>
              <a:rPr lang="en-US" sz="1200" baseline="300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,</a:t>
            </a:r>
            <a:r>
              <a:rPr lang="en-US" sz="1200" b="1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Wolfgang Bernhard</a:t>
            </a:r>
            <a:r>
              <a:rPr lang="en-US" sz="1200" baseline="300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</a:t>
            </a:r>
            <a:endParaRPr lang="de-DE" sz="1400" b="1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/>
              <a:cs typeface="Arial Unicode MS"/>
            </a:endParaRPr>
          </a:p>
          <a:p>
            <a:pPr algn="just">
              <a:lnSpc>
                <a:spcPct val="200000"/>
              </a:lnSpc>
            </a:pPr>
            <a:r>
              <a:rPr lang="en-US" sz="1200" b="1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Affiliations: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Times New Roman" panose="02020603050405020304" pitchFamily="18" charset="0"/>
              </a:rPr>
              <a:t>1Department of Neonatology, Eberhard </a:t>
            </a:r>
            <a:r>
              <a:rPr lang="en-US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Times New Roman" panose="02020603050405020304" pitchFamily="18" charset="0"/>
              </a:rPr>
              <a:t>Karls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Times New Roman" panose="02020603050405020304" pitchFamily="18" charset="0"/>
              </a:rPr>
              <a:t> University, Tübingen, Germany 2Center for Pediatric Clinical Studies, Eberhard </a:t>
            </a:r>
            <a:r>
              <a:rPr lang="en-US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Times New Roman" panose="02020603050405020304" pitchFamily="18" charset="0"/>
              </a:rPr>
              <a:t>Karls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Times New Roman" panose="02020603050405020304" pitchFamily="18" charset="0"/>
              </a:rPr>
              <a:t> University, Tübingen, Germany</a:t>
            </a:r>
            <a:endParaRPr lang="de-DE" sz="1200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Address of correspondence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: Katrin Alexandra Böckmann, MD, Department of Neonatology, Faculty of Medicine, Eberhard-</a:t>
            </a:r>
            <a:r>
              <a:rPr lang="en-US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Karls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-University, </a:t>
            </a:r>
            <a:r>
              <a:rPr lang="en-US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Calwer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Straße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7, D-72076 Tübingen, Germany; katrin.boeckmann@med.uni-tuebingen.de; Phone: +49 7071 29 84742</a:t>
            </a:r>
            <a:endParaRPr lang="de-DE" sz="1400" b="1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/>
              <a:cs typeface="Arial Unicode MS"/>
            </a:endParaRPr>
          </a:p>
        </p:txBody>
      </p:sp>
    </p:spTree>
    <p:extLst>
      <p:ext uri="{BB962C8B-B14F-4D97-AF65-F5344CB8AC3E}">
        <p14:creationId xmlns:p14="http://schemas.microsoft.com/office/powerpoint/2010/main" val="17083494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>
            <a:extLst>
              <a:ext uri="{FF2B5EF4-FFF2-40B4-BE49-F238E27FC236}">
                <a16:creationId xmlns:a16="http://schemas.microsoft.com/office/drawing/2014/main" id="{CE779A93-7E39-4D33-B350-2B286B72D718}"/>
              </a:ext>
            </a:extLst>
          </p:cNvPr>
          <p:cNvSpPr txBox="1"/>
          <p:nvPr/>
        </p:nvSpPr>
        <p:spPr>
          <a:xfrm>
            <a:off x="2032000" y="5152399"/>
            <a:ext cx="66423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de-DE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: Concentrations and administered amounts of choline, betaine and fatty acids in a butter pretzel.</a:t>
            </a:r>
            <a:endParaRPr lang="de-DE" sz="1200" dirty="0"/>
          </a:p>
        </p:txBody>
      </p:sp>
      <p:graphicFrame>
        <p:nvGraphicFramePr>
          <p:cNvPr id="3" name="Tabelle 2">
            <a:extLst>
              <a:ext uri="{FF2B5EF4-FFF2-40B4-BE49-F238E27FC236}">
                <a16:creationId xmlns:a16="http://schemas.microsoft.com/office/drawing/2014/main" id="{BAC710CC-6E06-4CA4-8A9C-E03A00A8D25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5884508"/>
              </p:ext>
            </p:extLst>
          </p:nvPr>
        </p:nvGraphicFramePr>
        <p:xfrm>
          <a:off x="2032000" y="811106"/>
          <a:ext cx="8128000" cy="399122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709333">
                  <a:extLst>
                    <a:ext uri="{9D8B030D-6E8A-4147-A177-3AD203B41FA5}">
                      <a16:colId xmlns:a16="http://schemas.microsoft.com/office/drawing/2014/main" val="420828964"/>
                    </a:ext>
                  </a:extLst>
                </a:gridCol>
                <a:gridCol w="1782015">
                  <a:extLst>
                    <a:ext uri="{9D8B030D-6E8A-4147-A177-3AD203B41FA5}">
                      <a16:colId xmlns:a16="http://schemas.microsoft.com/office/drawing/2014/main" val="727789822"/>
                    </a:ext>
                  </a:extLst>
                </a:gridCol>
                <a:gridCol w="1781666">
                  <a:extLst>
                    <a:ext uri="{9D8B030D-6E8A-4147-A177-3AD203B41FA5}">
                      <a16:colId xmlns:a16="http://schemas.microsoft.com/office/drawing/2014/main" val="1538567621"/>
                    </a:ext>
                  </a:extLst>
                </a:gridCol>
                <a:gridCol w="1854986">
                  <a:extLst>
                    <a:ext uri="{9D8B030D-6E8A-4147-A177-3AD203B41FA5}">
                      <a16:colId xmlns:a16="http://schemas.microsoft.com/office/drawing/2014/main" val="237278582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</a:pPr>
                      <a:r>
                        <a:rPr lang="de-DE" sz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ound</a:t>
                      </a:r>
                      <a:endParaRPr lang="de-DE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centration in mg/ butter pretzel (102g)</a:t>
                      </a:r>
                      <a:endParaRPr lang="de-DE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</a:pPr>
                      <a:endParaRPr lang="de-DE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centration in mg/ 1g butter pretzel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</a:pPr>
                      <a:endParaRPr lang="de-DE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raction</a:t>
                      </a: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of total </a:t>
                      </a:r>
                      <a:r>
                        <a:rPr lang="de-DE" sz="12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tty</a:t>
                      </a: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2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ids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Mol %)</a:t>
                      </a:r>
                    </a:p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</a:pPr>
                      <a:endParaRPr lang="de-DE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01017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holine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.9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2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</a:pPr>
                      <a:endParaRPr lang="de-DE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188697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taine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.3 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1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</a:pPr>
                      <a:endParaRPr lang="de-DE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1063724"/>
                  </a:ext>
                </a:extLst>
              </a:tr>
              <a:tr h="166434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lmitic acid 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07.6 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.9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</a:pPr>
                      <a:r>
                        <a:rPr lang="de-DE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9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7687613"/>
                  </a:ext>
                </a:extLst>
              </a:tr>
              <a:tr h="166434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2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earic</a:t>
                      </a: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2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id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28</a:t>
                      </a: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2</a:t>
                      </a: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</a:pPr>
                      <a:r>
                        <a:rPr lang="de-DE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2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9168971"/>
                  </a:ext>
                </a:extLst>
              </a:tr>
              <a:tr h="18542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leic acid 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17.8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.9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</a:pPr>
                      <a:r>
                        <a:rPr lang="de-DE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1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92248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noleic acid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15.8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.9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</a:pPr>
                      <a:r>
                        <a:rPr lang="de-DE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4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28538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rachidonic acid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4.1 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4 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</a:pPr>
                      <a:r>
                        <a:rPr lang="de-DE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6276447"/>
                  </a:ext>
                </a:extLst>
              </a:tr>
              <a:tr h="221911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2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ocosahexaenoic</a:t>
                      </a: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2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id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</a:pPr>
                      <a:r>
                        <a:rPr lang="de-DE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64264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samtfettsäuren</a:t>
                      </a: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875.2</a:t>
                      </a: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7.6</a:t>
                      </a: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0"/>
                        </a:spcBef>
                      </a:pPr>
                      <a:r>
                        <a:rPr lang="de-DE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42262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245182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>
            <a:extLst>
              <a:ext uri="{FF2B5EF4-FFF2-40B4-BE49-F238E27FC236}">
                <a16:creationId xmlns:a16="http://schemas.microsoft.com/office/drawing/2014/main" id="{E5C35862-BBAD-47F7-9A74-047B150EFDE9}"/>
              </a:ext>
            </a:extLst>
          </p:cNvPr>
          <p:cNvSpPr txBox="1"/>
          <p:nvPr/>
        </p:nvSpPr>
        <p:spPr>
          <a:xfrm>
            <a:off x="1576379" y="4269996"/>
            <a:ext cx="742425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 1: AUC (7d) of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9-choline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sm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igh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6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fter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ak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u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fferent D9-choline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D9 GPC=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9-alpha-glycerophosphocholine, D9-POPC= D9-1-palmitoyl-2-oleoyl-glycero-3-phosphoryl-choline,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C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de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rv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9= Deuterium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bell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55E4FC11-0C6C-4456-A1F6-87110B9CAB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6003" y="581099"/>
            <a:ext cx="9598925" cy="36888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85768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F6FDC031-D49B-40BE-9C8C-5410FC941C8F}"/>
              </a:ext>
            </a:extLst>
          </p:cNvPr>
          <p:cNvSpPr txBox="1"/>
          <p:nvPr/>
        </p:nvSpPr>
        <p:spPr>
          <a:xfrm>
            <a:off x="1073792" y="4916824"/>
            <a:ext cx="742425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. 2: AUC (7d) of D9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ain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sm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igh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6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fter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ak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u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fferent D9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lin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D9 GPC=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9-alpha-glycerophosphocholine, D9-POPC= D9-1-palmitoyl-2-oleoyl-glycero-3-phosphoryl-choline,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C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de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rv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9= Deuterium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bell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5208735D-F84C-4324-856D-932C38E579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3792" y="909675"/>
            <a:ext cx="9651952" cy="38160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98540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87218EFA-154D-4AB7-A635-6663FD9295C4}"/>
              </a:ext>
            </a:extLst>
          </p:cNvPr>
          <p:cNvSpPr txBox="1"/>
          <p:nvPr/>
        </p:nvSpPr>
        <p:spPr>
          <a:xfrm>
            <a:off x="1066021" y="5079596"/>
            <a:ext cx="742425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. 3: AUC (7d) of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9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lin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sm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6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fter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ak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u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fferent D9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lin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s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D9 GPC=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9-alpha-glycerophosphocholine, D9-POPC= D9-1-palmitoyl-2-oleoyl-glycero-3-phosphoryl-choline,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C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de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rv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9= Deuterium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bell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DA9AF17E-E4F0-4D5B-BECA-5FAC8D5603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5082" y="875130"/>
            <a:ext cx="11257610" cy="42044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82320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4A6D75A1-3F04-48A0-9C93-D4CAAB2E1833}"/>
              </a:ext>
            </a:extLst>
          </p:cNvPr>
          <p:cNvSpPr txBox="1"/>
          <p:nvPr/>
        </p:nvSpPr>
        <p:spPr>
          <a:xfrm>
            <a:off x="1029342" y="4718937"/>
            <a:ext cx="862321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. 4: AUC (7d) of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9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ain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sm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6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fter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ak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u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fferent D9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lin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D9 GPC=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9-alpha-glycerophosphocholine, D9-POPC= D9-1-palmitoyl-2-oleoyl-glycero-3-phosphoryl-choline,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C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de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rv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9= Deuterium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bell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A242C32D-83DF-4C05-999D-0E76B11908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8047" y="754068"/>
            <a:ext cx="9676263" cy="38256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67363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Diagramm 13">
            <a:extLst>
              <a:ext uri="{FF2B5EF4-FFF2-40B4-BE49-F238E27FC236}">
                <a16:creationId xmlns:a16="http://schemas.microsoft.com/office/drawing/2014/main" id="{1F46246D-FA62-4216-B27E-3AA1131E859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44392954"/>
              </p:ext>
            </p:extLst>
          </p:nvPr>
        </p:nvGraphicFramePr>
        <p:xfrm>
          <a:off x="5929162" y="333376"/>
          <a:ext cx="4812921" cy="5105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feld 2">
            <a:extLst>
              <a:ext uri="{FF2B5EF4-FFF2-40B4-BE49-F238E27FC236}">
                <a16:creationId xmlns:a16="http://schemas.microsoft.com/office/drawing/2014/main" id="{6ED1FC54-17A3-4AD4-9854-CEF5574AB9FB}"/>
              </a:ext>
            </a:extLst>
          </p:cNvPr>
          <p:cNvSpPr txBox="1"/>
          <p:nvPr/>
        </p:nvSpPr>
        <p:spPr>
          <a:xfrm>
            <a:off x="885524" y="5466882"/>
            <a:ext cx="982739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. 5: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latio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cursor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9-enrichment (D9-betaine) and D3-PC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sma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6-24h (A) and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sma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D3-PC in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pons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fferent D9-choline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. Data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vidual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ta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int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dian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quartil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ng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N=6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oup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GPC,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erophosphocholin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POPC, 1-palmitoyl-2-oleoyl-phosphatidylcholine;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not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ifican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,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ificanc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vel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de-DE" sz="1400" dirty="0">
                <a:latin typeface="Symbol" panose="05050102010706020507" pitchFamily="18" charset="2"/>
                <a:cs typeface="Times New Roman" panose="02020603050405020304" pitchFamily="18" charset="0"/>
              </a:rPr>
              <a:t>r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pearman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latio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efficien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not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ifican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2D6235FE-BEE0-4828-AAF9-C2A7916A45F5}"/>
              </a:ext>
            </a:extLst>
          </p:cNvPr>
          <p:cNvSpPr txBox="1"/>
          <p:nvPr/>
        </p:nvSpPr>
        <p:spPr>
          <a:xfrm>
            <a:off x="8213559" y="474848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n.s</a:t>
            </a:r>
            <a:r>
              <a:rPr lang="de-DE" dirty="0"/>
              <a:t>.</a:t>
            </a:r>
          </a:p>
        </p:txBody>
      </p:sp>
      <p:graphicFrame>
        <p:nvGraphicFramePr>
          <p:cNvPr id="13" name="Diagramm 12">
            <a:extLst>
              <a:ext uri="{FF2B5EF4-FFF2-40B4-BE49-F238E27FC236}">
                <a16:creationId xmlns:a16="http://schemas.microsoft.com/office/drawing/2014/main" id="{5B6545BA-3389-4D11-B2FA-68B20DEA3FD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5101997"/>
              </p:ext>
            </p:extLst>
          </p:nvPr>
        </p:nvGraphicFramePr>
        <p:xfrm>
          <a:off x="885525" y="428625"/>
          <a:ext cx="4928134" cy="49230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5" name="Gerader Verbinder 14">
            <a:extLst>
              <a:ext uri="{FF2B5EF4-FFF2-40B4-BE49-F238E27FC236}">
                <a16:creationId xmlns:a16="http://schemas.microsoft.com/office/drawing/2014/main" id="{4F65644D-EB86-4E90-B0DC-A5EB9689557F}"/>
              </a:ext>
            </a:extLst>
          </p:cNvPr>
          <p:cNvCxnSpPr>
            <a:cxnSpLocks/>
          </p:cNvCxnSpPr>
          <p:nvPr/>
        </p:nvCxnSpPr>
        <p:spPr>
          <a:xfrm flipH="1">
            <a:off x="6833938" y="875899"/>
            <a:ext cx="3493969" cy="0"/>
          </a:xfrm>
          <a:prstGeom prst="line">
            <a:avLst/>
          </a:prstGeom>
          <a:ln w="19050">
            <a:solidFill>
              <a:schemeClr val="tx1"/>
            </a:solidFill>
            <a:headEnd type="diamond" w="med" len="med"/>
            <a:tailEnd type="diamond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49101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63</Words>
  <Application>Microsoft Office PowerPoint</Application>
  <PresentationFormat>Breitbild</PresentationFormat>
  <Paragraphs>60</Paragraphs>
  <Slides>7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7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15" baseType="lpstr">
      <vt:lpstr>Arial</vt:lpstr>
      <vt:lpstr>Arial Narrow</vt:lpstr>
      <vt:lpstr>Arial Unicode MS</vt:lpstr>
      <vt:lpstr>Calibri</vt:lpstr>
      <vt:lpstr>Calibri Light</vt:lpstr>
      <vt:lpstr>Symbol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Katrin Böckmann</dc:creator>
  <cp:lastModifiedBy>Dr. Katrin Böckmann</cp:lastModifiedBy>
  <cp:revision>55</cp:revision>
  <dcterms:created xsi:type="dcterms:W3CDTF">2022-07-07T15:15:02Z</dcterms:created>
  <dcterms:modified xsi:type="dcterms:W3CDTF">2023-02-13T18:33:04Z</dcterms:modified>
</cp:coreProperties>
</file>